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12193588" cy="6858000"/>
  <p:notesSz cx="7772400" cy="100584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6DA8E330-3EF8-43CD-A9CA-EC464BD4FC1D}" type="slidenum">
              <a:t>&lt;#&gt;</a:t>
            </a:fld>
          </a:p>
        </p:txBody>
      </p:sp>
      <p:sp>
        <p:nvSpPr>
          <p:cNvPr id="3" name="PlaceHolder 2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4160" cy="13240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4160" cy="20746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8080" y="4097520"/>
            <a:ext cx="10514160" cy="20746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F7BA057B-57C3-4599-8552-C15CB125668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4160" cy="13240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0720" cy="20746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25840" y="1825200"/>
            <a:ext cx="5130720" cy="20746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38080" y="4097520"/>
            <a:ext cx="5130720" cy="20746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25840" y="4097520"/>
            <a:ext cx="5130720" cy="20746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E151CCF8-A239-4576-9618-0222633981B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4160" cy="13240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440" cy="20746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93080" y="1825200"/>
            <a:ext cx="3385440" cy="20746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948440" y="1825200"/>
            <a:ext cx="3385440" cy="20746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38080" y="4097520"/>
            <a:ext cx="3385440" cy="20746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93080" y="4097520"/>
            <a:ext cx="3385440" cy="20746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948440" y="4097520"/>
            <a:ext cx="3385440" cy="20746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A8B3CCF4-BC06-4A70-8DBA-9248FBB03E0A}" type="slidenum">
              <a:t>&lt;#&gt;</a:t>
            </a:fld>
          </a:p>
        </p:txBody>
      </p:sp>
      <p:sp>
        <p:nvSpPr>
          <p:cNvPr id="10" name="PlaceHolder 9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4160" cy="13240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4160" cy="4349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4E08AA33-C4B6-4C3C-8AE9-FF2E8B10AEA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4160" cy="13240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4160" cy="43498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CB6320EA-8A36-4056-B6AE-DB101E66D7C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4160" cy="13240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0720" cy="43498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25840" y="1825200"/>
            <a:ext cx="5130720" cy="43498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F3412FC8-C15D-4D9F-89AA-BC252123A1D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4160" cy="13240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A69063E1-E506-4DE8-A5F6-9906403FD5D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4160" cy="6139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-343080"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FA2C09C3-997D-4A85-ADC2-0982D135886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4160" cy="13240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0720" cy="20746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5840" y="1825200"/>
            <a:ext cx="5130720" cy="43498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38080" y="4097520"/>
            <a:ext cx="5130720" cy="20746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C51D5AAC-9AE8-4BC4-AD19-E3065AA29FB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4160" cy="13240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0720" cy="43498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25840" y="1825200"/>
            <a:ext cx="5130720" cy="20746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25840" y="4097520"/>
            <a:ext cx="5130720" cy="20746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EFAD76AE-375A-41FD-8F9E-6DB1D6E66B5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4160" cy="13240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0720" cy="20746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25840" y="1825200"/>
            <a:ext cx="5130720" cy="20746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38080" y="4097520"/>
            <a:ext cx="10514160" cy="20746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AE5A33B7-E5E1-4A6C-B6DC-48562851356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4160" cy="13240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4160" cy="43498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343080" indent="-343080">
              <a:lnSpc>
                <a:spcPct val="9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343080" indent="-343080">
              <a:lnSpc>
                <a:spcPct val="9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•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343080" indent="-343080">
              <a:lnSpc>
                <a:spcPct val="9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343080" indent="-343080">
              <a:lnSpc>
                <a:spcPct val="9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343080" indent="-343080">
              <a:lnSpc>
                <a:spcPct val="9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343080" indent="-343080">
              <a:lnSpc>
                <a:spcPct val="9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38080" y="6356160"/>
            <a:ext cx="2741760" cy="3632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217188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US" sz="18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217188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11/30/1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"/>
          <p:cNvSpPr/>
          <p:nvPr/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4"/>
          <p:cNvSpPr>
            <a:spLocks noGrp="1"/>
          </p:cNvSpPr>
          <p:nvPr>
            <p:ph type="sldNum" idx="2"/>
          </p:nvPr>
        </p:nvSpPr>
        <p:spPr>
          <a:xfrm>
            <a:off x="8610480" y="6356160"/>
            <a:ext cx="2741760" cy="3632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217188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US" sz="18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217188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fld id="{109DBD89-5041-4E2C-A7FD-BB61316C3B3E}" type="slidenum">
              <a:rPr b="0" lang="en-US" sz="18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3971880" y="1824120"/>
            <a:ext cx="1440000" cy="1439640"/>
            <a:chOff x="3971880" y="1824120"/>
            <a:chExt cx="1440000" cy="1439640"/>
          </a:xfrm>
        </p:grpSpPr>
        <p:pic>
          <p:nvPicPr>
            <p:cNvPr id="42" name="" descr=""/>
            <p:cNvPicPr/>
            <p:nvPr/>
          </p:nvPicPr>
          <p:blipFill>
            <a:blip r:embed="rId1"/>
            <a:stretch/>
          </p:blipFill>
          <p:spPr>
            <a:xfrm>
              <a:off x="3971880" y="1824120"/>
              <a:ext cx="1440000" cy="1439640"/>
            </a:xfrm>
            <a:prstGeom prst="rect">
              <a:avLst/>
            </a:prstGeom>
            <a:ln w="9360">
              <a:solidFill>
                <a:srgbClr val="000000"/>
              </a:solidFill>
              <a:round/>
            </a:ln>
          </p:spPr>
        </p:pic>
        <p:sp>
          <p:nvSpPr>
            <p:cNvPr id="43" name=""/>
            <p:cNvSpPr/>
            <p:nvPr/>
          </p:nvSpPr>
          <p:spPr>
            <a:xfrm>
              <a:off x="4940280" y="3160800"/>
              <a:ext cx="338040" cy="144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4" name=""/>
          <p:cNvSpPr/>
          <p:nvPr/>
        </p:nvSpPr>
        <p:spPr>
          <a:xfrm>
            <a:off x="1533600" y="3263760"/>
            <a:ext cx="6578640" cy="2692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tIns="91440" anchor="t">
            <a:spAutoFit/>
          </a:bodyPr>
          <a:p>
            <a:pPr algn="just">
              <a:lnSpc>
                <a:spcPct val="150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651528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  <a:ea typeface="Calibri"/>
              </a:rPr>
              <a:t>Additional file 2: Figure S2. Transmission electron micrograph of sucrose density gradient purified VP2/6 particles. </a:t>
            </a:r>
            <a:r>
              <a:rPr b="0" lang="en-US" sz="1600" spc="-1" strike="noStrike">
                <a:solidFill>
                  <a:srgbClr val="000000"/>
                </a:solidFill>
                <a:latin typeface="Calibri"/>
                <a:ea typeface="Calibri"/>
              </a:rPr>
              <a:t>Purified VP2/6 fractions were pooled together and dialysed in high salt PBS to remove sucrose before viewing on a transmission electron microscope. Most of the VLPs remained intact but some appeared to have lost shape probably as a result of deformation due to the conditions on the EM grid.</a:t>
            </a:r>
            <a:r>
              <a:rPr b="1" lang="en-US" sz="1600" spc="-1" strike="noStrike">
                <a:solidFill>
                  <a:srgbClr val="000000"/>
                </a:solidFill>
                <a:latin typeface="Calibri"/>
                <a:ea typeface="Calibri"/>
              </a:rPr>
              <a:t> </a:t>
            </a:r>
            <a:r>
              <a:rPr b="0" lang="en-US" sz="1600" spc="-1" strike="noStrike">
                <a:solidFill>
                  <a:srgbClr val="000000"/>
                </a:solidFill>
                <a:latin typeface="Calibri"/>
                <a:ea typeface="Calibri"/>
              </a:rPr>
              <a:t>Samples were captured with mouse-anti VP6 antibody (1/500). Bar represents 100 nm.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/>
  <cp:revision>0</cp:revision>
  <dc:subject/>
  <dc:title/>
</cp:coreProperties>
</file>